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0" r:id="rId2"/>
  </p:sldIdLst>
  <p:sldSz cx="6858000" cy="9144000" type="screen4x3"/>
  <p:notesSz cx="6802438" cy="9934575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159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9900"/>
    <a:srgbClr val="7F7F7F"/>
    <a:srgbClr val="646464"/>
    <a:srgbClr val="8282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3194" autoAdjust="0"/>
  </p:normalViewPr>
  <p:slideViewPr>
    <p:cSldViewPr snapToGrid="0" snapToObjects="1">
      <p:cViewPr varScale="1">
        <p:scale>
          <a:sx n="81" d="100"/>
          <a:sy n="81" d="100"/>
        </p:scale>
        <p:origin x="784" y="76"/>
      </p:cViewPr>
      <p:guideLst>
        <p:guide orient="horz" pos="2880"/>
        <p:guide pos="2160"/>
        <p:guide orient="horz" pos="159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47343F-9011-4E48-ACD0-AFDBFF8B6C7E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1241425"/>
            <a:ext cx="2513012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F467D0-B869-419D-8DA9-B631581B19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186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873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524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469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4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562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52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606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319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747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419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486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ltGray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645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FD03A6BE-22E8-4DA0-8AE8-945DACA52A24}"/>
              </a:ext>
            </a:extLst>
          </p:cNvPr>
          <p:cNvGrpSpPr/>
          <p:nvPr/>
        </p:nvGrpSpPr>
        <p:grpSpPr>
          <a:xfrm>
            <a:off x="162689" y="5347191"/>
            <a:ext cx="6361089" cy="3000673"/>
            <a:chOff x="148513" y="4135083"/>
            <a:chExt cx="6361089" cy="3000673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4078" y="4135083"/>
              <a:ext cx="2927248" cy="1443048"/>
            </a:xfrm>
            <a:prstGeom prst="rect">
              <a:avLst/>
            </a:prstGeom>
          </p:spPr>
        </p:pic>
        <p:pic>
          <p:nvPicPr>
            <p:cNvPr id="3" name="図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71971" y="4137522"/>
              <a:ext cx="2929991" cy="1440305"/>
            </a:xfrm>
            <a:prstGeom prst="rect">
              <a:avLst/>
            </a:prstGeom>
          </p:spPr>
        </p:pic>
        <p:pic>
          <p:nvPicPr>
            <p:cNvPr id="4" name="図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1640" y="5687295"/>
              <a:ext cx="2929991" cy="1443048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74409" y="5687295"/>
              <a:ext cx="2927248" cy="1443048"/>
            </a:xfrm>
            <a:prstGeom prst="rect">
              <a:avLst/>
            </a:prstGeom>
          </p:spPr>
        </p:pic>
        <p:sp>
          <p:nvSpPr>
            <p:cNvPr id="6" name="テキスト ボックス 5"/>
            <p:cNvSpPr txBox="1"/>
            <p:nvPr/>
          </p:nvSpPr>
          <p:spPr>
            <a:xfrm>
              <a:off x="386135" y="4354364"/>
              <a:ext cx="292388" cy="80903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PBMC (x 10</a:t>
              </a:r>
              <a:r>
                <a:rPr lang="en-US" altLang="ja-JP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3675546" y="4252762"/>
              <a:ext cx="292388" cy="103703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Viability (%) of PBMC</a:t>
              </a:r>
              <a:endParaRPr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3675546" y="5992040"/>
              <a:ext cx="292388" cy="62915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 (x 10</a:t>
              </a:r>
              <a:r>
                <a:rPr lang="en-US" altLang="ja-JP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86135" y="5856572"/>
              <a:ext cx="292388" cy="92493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 (%) of PBMC</a:t>
              </a:r>
              <a:endParaRPr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836786" y="6951090"/>
              <a:ext cx="28194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107832" y="6951090"/>
              <a:ext cx="41897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463248" y="6951090"/>
              <a:ext cx="4026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780344" y="6951090"/>
              <a:ext cx="4621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2134639" y="6951090"/>
              <a:ext cx="4456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NF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2395177" y="6951090"/>
              <a:ext cx="59767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L-6/IL-6R</a:t>
              </a: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2859149" y="6951090"/>
              <a:ext cx="3643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L-10</a:t>
              </a: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148513" y="6951090"/>
              <a:ext cx="695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re-treatment</a:t>
              </a: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4122882" y="6951090"/>
              <a:ext cx="28194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4393928" y="6951090"/>
              <a:ext cx="41897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4749344" y="6951090"/>
              <a:ext cx="4026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5066440" y="6951090"/>
              <a:ext cx="4621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5420735" y="6951090"/>
              <a:ext cx="4456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NF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5681273" y="6951090"/>
              <a:ext cx="59767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L-6/IL-6R</a:t>
              </a: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6145245" y="6951090"/>
              <a:ext cx="3643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L-10</a:t>
              </a: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3434609" y="6951090"/>
              <a:ext cx="695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re-treatment</a:t>
              </a: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B0E42AE0-C079-4652-81E6-DDF9E6E9EF6D}"/>
              </a:ext>
            </a:extLst>
          </p:cNvPr>
          <p:cNvGrpSpPr/>
          <p:nvPr/>
        </p:nvGrpSpPr>
        <p:grpSpPr>
          <a:xfrm>
            <a:off x="408587" y="481095"/>
            <a:ext cx="5471252" cy="4154967"/>
            <a:chOff x="429851" y="247182"/>
            <a:chExt cx="5471252" cy="4154967"/>
          </a:xfrm>
        </p:grpSpPr>
        <p:pic>
          <p:nvPicPr>
            <p:cNvPr id="42" name="図 41">
              <a:extLst>
                <a:ext uri="{FF2B5EF4-FFF2-40B4-BE49-F238E27FC236}">
                  <a16:creationId xmlns:a16="http://schemas.microsoft.com/office/drawing/2014/main" id="{0D61B2C3-C434-493F-AD52-5A4F25D80AF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06755" y="3045618"/>
              <a:ext cx="2345944" cy="1282710"/>
            </a:xfrm>
            <a:prstGeom prst="rect">
              <a:avLst/>
            </a:prstGeom>
          </p:spPr>
        </p:pic>
        <p:pic>
          <p:nvPicPr>
            <p:cNvPr id="43" name="図 42">
              <a:extLst>
                <a:ext uri="{FF2B5EF4-FFF2-40B4-BE49-F238E27FC236}">
                  <a16:creationId xmlns:a16="http://schemas.microsoft.com/office/drawing/2014/main" id="{CA08519F-4952-4E9C-A6D1-65E861D72ED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15290" y="475698"/>
              <a:ext cx="2336190" cy="1280271"/>
            </a:xfrm>
            <a:prstGeom prst="rect">
              <a:avLst/>
            </a:prstGeom>
          </p:spPr>
        </p:pic>
        <p:pic>
          <p:nvPicPr>
            <p:cNvPr id="44" name="図 43">
              <a:extLst>
                <a:ext uri="{FF2B5EF4-FFF2-40B4-BE49-F238E27FC236}">
                  <a16:creationId xmlns:a16="http://schemas.microsoft.com/office/drawing/2014/main" id="{DBF4F4F5-3C43-4C31-9037-4616BC97D1F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08889" y="1756736"/>
              <a:ext cx="2343506" cy="1282710"/>
            </a:xfrm>
            <a:prstGeom prst="rect">
              <a:avLst/>
            </a:prstGeom>
          </p:spPr>
        </p:pic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F436A287-B659-4D57-A518-C62A4BE7A1D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484465" y="3032816"/>
              <a:ext cx="2306926" cy="1297341"/>
            </a:xfrm>
            <a:prstGeom prst="rect">
              <a:avLst/>
            </a:prstGeom>
          </p:spPr>
        </p:pic>
        <p:pic>
          <p:nvPicPr>
            <p:cNvPr id="46" name="図 45">
              <a:extLst>
                <a:ext uri="{FF2B5EF4-FFF2-40B4-BE49-F238E27FC236}">
                  <a16:creationId xmlns:a16="http://schemas.microsoft.com/office/drawing/2014/main" id="{0636DD9B-3BA1-49EE-B132-9C5FE9FAC6E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470064" y="460761"/>
              <a:ext cx="2306926" cy="1297341"/>
            </a:xfrm>
            <a:prstGeom prst="rect">
              <a:avLst/>
            </a:prstGeom>
          </p:spPr>
        </p:pic>
        <p:pic>
          <p:nvPicPr>
            <p:cNvPr id="47" name="図 46">
              <a:extLst>
                <a:ext uri="{FF2B5EF4-FFF2-40B4-BE49-F238E27FC236}">
                  <a16:creationId xmlns:a16="http://schemas.microsoft.com/office/drawing/2014/main" id="{AA01BBA9-028C-41CE-B9D5-935825B978B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470064" y="1743934"/>
              <a:ext cx="2306926" cy="1297341"/>
            </a:xfrm>
            <a:prstGeom prst="rect">
              <a:avLst/>
            </a:prstGeom>
          </p:spPr>
        </p:pic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5DF2680B-6EA7-4383-9563-1E467309F1E3}"/>
                </a:ext>
              </a:extLst>
            </p:cNvPr>
            <p:cNvSpPr txBox="1"/>
            <p:nvPr/>
          </p:nvSpPr>
          <p:spPr>
            <a:xfrm>
              <a:off x="5040148" y="466753"/>
              <a:ext cx="7627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□  No stim.</a:t>
              </a:r>
            </a:p>
            <a:p>
              <a:r>
                <a:rPr lang="en-US" altLang="ja-JP" sz="7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■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  TLR9 stim.</a:t>
              </a: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6ED98366-B5CE-444D-995C-F7B1077CF3C9}"/>
                </a:ext>
              </a:extLst>
            </p:cNvPr>
            <p:cNvSpPr txBox="1"/>
            <p:nvPr/>
          </p:nvSpPr>
          <p:spPr>
            <a:xfrm>
              <a:off x="1445467" y="4179011"/>
              <a:ext cx="308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973E69FE-9B26-4249-BAC3-388CE8CF3555}"/>
                </a:ext>
              </a:extLst>
            </p:cNvPr>
            <p:cNvSpPr txBox="1"/>
            <p:nvPr/>
          </p:nvSpPr>
          <p:spPr>
            <a:xfrm>
              <a:off x="1709315" y="4140539"/>
              <a:ext cx="5737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(10 U/mL)</a:t>
              </a: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8B821C62-A4E5-440B-A49D-0132DFBF7080}"/>
                </a:ext>
              </a:extLst>
            </p:cNvPr>
            <p:cNvSpPr txBox="1"/>
            <p:nvPr/>
          </p:nvSpPr>
          <p:spPr>
            <a:xfrm>
              <a:off x="2092569" y="4140539"/>
              <a:ext cx="5543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(10 U/mL)</a:t>
              </a: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803ACD6F-4455-4122-954C-A649A5D4B9DA}"/>
                </a:ext>
              </a:extLst>
            </p:cNvPr>
            <p:cNvSpPr txBox="1"/>
            <p:nvPr/>
          </p:nvSpPr>
          <p:spPr>
            <a:xfrm>
              <a:off x="2458545" y="4140539"/>
              <a:ext cx="6142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(10 ng/mL)</a:t>
              </a: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22EB8752-3E53-44CB-9979-CF0CCD2F861D}"/>
                </a:ext>
              </a:extLst>
            </p:cNvPr>
            <p:cNvSpPr txBox="1"/>
            <p:nvPr/>
          </p:nvSpPr>
          <p:spPr>
            <a:xfrm>
              <a:off x="2826658" y="4140539"/>
              <a:ext cx="6142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NF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(10 ng/mL)</a:t>
              </a: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CB7E935D-34BA-4ABC-944E-5C5879895AA7}"/>
                </a:ext>
              </a:extLst>
            </p:cNvPr>
            <p:cNvSpPr txBox="1"/>
            <p:nvPr/>
          </p:nvSpPr>
          <p:spPr>
            <a:xfrm>
              <a:off x="660218" y="4179011"/>
              <a:ext cx="68232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re-treatment</a:t>
              </a: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D3661A30-FF05-483F-9A6F-60C46E7F75D3}"/>
                </a:ext>
              </a:extLst>
            </p:cNvPr>
            <p:cNvSpPr txBox="1"/>
            <p:nvPr/>
          </p:nvSpPr>
          <p:spPr>
            <a:xfrm>
              <a:off x="1764823" y="247182"/>
              <a:ext cx="11184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oxoribine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TLR7)</a:t>
              </a: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24F2E516-87E8-44CB-9B64-10433B6C4E30}"/>
                </a:ext>
              </a:extLst>
            </p:cNvPr>
            <p:cNvSpPr txBox="1"/>
            <p:nvPr/>
          </p:nvSpPr>
          <p:spPr>
            <a:xfrm>
              <a:off x="4436136" y="247182"/>
              <a:ext cx="11184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pG2216 (TLR9)</a:t>
              </a: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D7F2BB15-7DC8-4565-AE4D-8B84D1E3829B}"/>
                </a:ext>
              </a:extLst>
            </p:cNvPr>
            <p:cNvSpPr txBox="1"/>
            <p:nvPr/>
          </p:nvSpPr>
          <p:spPr>
            <a:xfrm>
              <a:off x="545064" y="898931"/>
              <a:ext cx="5235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2b</a:t>
              </a: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93F35B6D-C11E-40F1-B41C-FC2686E4F97B}"/>
                </a:ext>
              </a:extLst>
            </p:cNvPr>
            <p:cNvSpPr txBox="1"/>
            <p:nvPr/>
          </p:nvSpPr>
          <p:spPr>
            <a:xfrm>
              <a:off x="429851" y="2127871"/>
              <a:ext cx="75392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(without</a:t>
              </a:r>
            </a:p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 IFN-</a:t>
              </a:r>
              <a:r>
                <a:rPr lang="el-GR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2b)</a:t>
              </a: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C0FB7650-E6DD-453D-8F60-4EBF637DF0FD}"/>
                </a:ext>
              </a:extLst>
            </p:cNvPr>
            <p:cNvSpPr txBox="1"/>
            <p:nvPr/>
          </p:nvSpPr>
          <p:spPr>
            <a:xfrm>
              <a:off x="598318" y="3440962"/>
              <a:ext cx="416993" cy="20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altLang="ja-JP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0862FE35-C09F-4B48-B534-6EAABE972EAB}"/>
                </a:ext>
              </a:extLst>
            </p:cNvPr>
            <p:cNvSpPr txBox="1"/>
            <p:nvPr/>
          </p:nvSpPr>
          <p:spPr>
            <a:xfrm>
              <a:off x="2637139" y="427558"/>
              <a:ext cx="7627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□  No stim.</a:t>
              </a:r>
            </a:p>
            <a:p>
              <a:r>
                <a:rPr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■  TLR7 stim.</a:t>
              </a: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0F242285-3BAA-43E1-9D87-CA7832406DB2}"/>
                </a:ext>
              </a:extLst>
            </p:cNvPr>
            <p:cNvSpPr txBox="1"/>
            <p:nvPr/>
          </p:nvSpPr>
          <p:spPr>
            <a:xfrm>
              <a:off x="3914359" y="4174650"/>
              <a:ext cx="308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22E932BD-D8DA-4364-B75B-6AC32328AB72}"/>
                </a:ext>
              </a:extLst>
            </p:cNvPr>
            <p:cNvSpPr txBox="1"/>
            <p:nvPr/>
          </p:nvSpPr>
          <p:spPr>
            <a:xfrm>
              <a:off x="4152080" y="4136178"/>
              <a:ext cx="5737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(10 U/mL)</a:t>
              </a: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A3229DA6-99A5-4D7F-9B25-20C21226F058}"/>
                </a:ext>
              </a:extLst>
            </p:cNvPr>
            <p:cNvSpPr txBox="1"/>
            <p:nvPr/>
          </p:nvSpPr>
          <p:spPr>
            <a:xfrm>
              <a:off x="4552752" y="4136178"/>
              <a:ext cx="55436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(10 U/mL)</a:t>
              </a: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D05E77E5-16F1-429F-9CC7-5B4180AEE383}"/>
                </a:ext>
              </a:extLst>
            </p:cNvPr>
            <p:cNvSpPr txBox="1"/>
            <p:nvPr/>
          </p:nvSpPr>
          <p:spPr>
            <a:xfrm>
              <a:off x="4892601" y="4136178"/>
              <a:ext cx="6142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γ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(10 ng/mL)</a:t>
              </a: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A15143E5-9A17-4FED-AB0F-7EAAE93868CF}"/>
                </a:ext>
              </a:extLst>
            </p:cNvPr>
            <p:cNvSpPr txBox="1"/>
            <p:nvPr/>
          </p:nvSpPr>
          <p:spPr>
            <a:xfrm>
              <a:off x="5286841" y="4136178"/>
              <a:ext cx="6142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NF-</a:t>
              </a:r>
              <a:r>
                <a:rPr lang="el-GR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(10 ng/mL)</a:t>
              </a:r>
            </a:p>
          </p:txBody>
        </p:sp>
      </p:grp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714B18D4-0938-4568-81F6-F6009E8588AB}"/>
              </a:ext>
            </a:extLst>
          </p:cNvPr>
          <p:cNvSpPr txBox="1"/>
          <p:nvPr/>
        </p:nvSpPr>
        <p:spPr>
          <a:xfrm>
            <a:off x="218017" y="446352"/>
            <a:ext cx="3311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789126C6-A43A-472E-92F3-58C3D86648AE}"/>
              </a:ext>
            </a:extLst>
          </p:cNvPr>
          <p:cNvSpPr txBox="1"/>
          <p:nvPr/>
        </p:nvSpPr>
        <p:spPr>
          <a:xfrm>
            <a:off x="218017" y="5132284"/>
            <a:ext cx="3311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079156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30</TotalTime>
  <Words>154</Words>
  <Application>Microsoft Office PowerPoint</Application>
  <PresentationFormat>画面に合わせる (4:3)</PresentationFormat>
  <Paragraphs>5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Symbol</vt:lpstr>
      <vt:lpstr>ホワイト</vt:lpstr>
      <vt:lpstr>PowerPoint プレゼンテーション</vt:lpstr>
    </vt:vector>
  </TitlesOfParts>
  <Company>UOE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WATA SHIGERU</dc:creator>
  <cp:lastModifiedBy>圭 阪田</cp:lastModifiedBy>
  <cp:revision>301</cp:revision>
  <cp:lastPrinted>2017-04-10T01:20:45Z</cp:lastPrinted>
  <dcterms:created xsi:type="dcterms:W3CDTF">2016-08-30T03:40:23Z</dcterms:created>
  <dcterms:modified xsi:type="dcterms:W3CDTF">2018-07-25T02:22:37Z</dcterms:modified>
</cp:coreProperties>
</file>